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590" r:id="rId2"/>
    <p:sldId id="298" r:id="rId3"/>
    <p:sldId id="521" r:id="rId4"/>
  </p:sldIdLst>
  <p:sldSz cx="12192000" cy="6858000"/>
  <p:notesSz cx="6858000" cy="9144000"/>
  <p:defaultTextStyle>
    <a:defPPr>
      <a:defRPr lang="en-JP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988"/>
  </p:normalViewPr>
  <p:slideViewPr>
    <p:cSldViewPr snapToGrid="0">
      <p:cViewPr varScale="1">
        <p:scale>
          <a:sx n="118" d="100"/>
          <a:sy n="118" d="100"/>
        </p:scale>
        <p:origin x="36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JP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933071-E61F-E246-A01C-F9B293C7FA0D}" type="datetimeFigureOut">
              <a:rPr lang="en-JP" smtClean="0"/>
              <a:t>2023/06/20</a:t>
            </a:fld>
            <a:endParaRPr lang="en-JP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JP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6E52E3-2081-F947-A17A-DE4363C57618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1974608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C15A59-2396-BA4F-BB8C-9E60C7375FE5}" type="slidenum">
              <a:rPr lang="en-JP" smtClean="0"/>
              <a:t>2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9339011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72FC4B-8947-CDC1-542C-15281C964F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JP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45F80FB-1BEF-43F1-63B7-067808BAB2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792DE3-A055-30C7-BD1A-12505231C6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2E738-34EC-3F48-B735-D9EF3143412C}" type="datetimeFigureOut">
              <a:rPr lang="en-JP" smtClean="0"/>
              <a:t>2023/06/20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F0B74D-5585-80CB-CFC1-4FEE4530F0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F23158-05C6-635C-2CB6-C083AD32A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66D73-07E6-AA45-862D-7F8EF713986E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2669352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798F95-4DFF-43FE-5FAA-A465542E36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JP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4B0377-03C2-065C-E1CE-3B8FBBB769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8BA218-5BD8-DA91-DF6C-285D1EEA5A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2E738-34EC-3F48-B735-D9EF3143412C}" type="datetimeFigureOut">
              <a:rPr lang="en-JP" smtClean="0"/>
              <a:t>2023/06/20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26AFBB-4E7C-CEB7-EC41-905CD81CDF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8D562C-3044-0D2F-B70A-94E34965F3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66D73-07E6-AA45-862D-7F8EF713986E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2304638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D5EF543-5F3A-BB1F-35E3-2A613F280F6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JP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156066F-A1B4-B0CB-A37E-242AAC814D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3D8641-BB89-866D-369C-2C2651E015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2E738-34EC-3F48-B735-D9EF3143412C}" type="datetimeFigureOut">
              <a:rPr lang="en-JP" smtClean="0"/>
              <a:t>2023/06/20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3F56A6-13D7-20BE-FB65-5D679E148E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9ED93E-2CF4-61BA-9AD7-FFAFE91F38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66D73-07E6-AA45-862D-7F8EF713986E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4152392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ED65B1-4E3A-940F-878B-22F8A5296A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FA8E3C-9FE4-5D89-DA56-9D547371D77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5D1059-8328-A652-0957-9E9B5C0C6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2E738-34EC-3F48-B735-D9EF3143412C}" type="datetimeFigureOut">
              <a:rPr lang="en-JP" smtClean="0"/>
              <a:t>2023/06/20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0C6041-810B-5A60-378A-DC6A4B87BE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00FA65-611E-683E-3BB9-EBC3AA3A5D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66D73-07E6-AA45-862D-7F8EF713986E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182756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93A5D5-9DC7-3BA1-8E94-152B6A64DA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B0106A-9475-5DFF-34A3-0E0AF7D2A1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C43E6F-EB16-5F13-7761-E25A699138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2E738-34EC-3F48-B735-D9EF3143412C}" type="datetimeFigureOut">
              <a:rPr lang="en-JP" smtClean="0"/>
              <a:t>2023/06/20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98B1D0-38FC-D566-631A-70C4CF1279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52EDC6-9760-F9D5-9750-48465364EB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66D73-07E6-AA45-862D-7F8EF713986E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897524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E183B6-6AFA-1069-5032-D8C9D32CF1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0DECA1-A148-74D0-06D7-395E93198C4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JP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3003D1-D9DD-FA16-1A01-C05C7FF92D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JP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B99B38-35AE-EDC9-FBE7-C7A0924731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2E738-34EC-3F48-B735-D9EF3143412C}" type="datetimeFigureOut">
              <a:rPr lang="en-JP" smtClean="0"/>
              <a:t>2023/06/20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6BA04E-F9ED-6C5A-59DA-780D672F04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9D9371-2E47-E515-3351-6283F54EF5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66D73-07E6-AA45-862D-7F8EF713986E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9958239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B0D2C7-CDDB-A87D-7AD1-B7BE631D68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6D49D0-455B-C898-C2DE-4A94C6D3BD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AED86E-212C-C804-A4CD-66ED2B7CB0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JP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B54EE99-27DD-FA00-7FA9-BA04CA8E611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6EA69B5-CEB4-4E68-4A29-181CACAC170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JP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67F69DB-4810-443A-DB57-2D57C3262E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2E738-34EC-3F48-B735-D9EF3143412C}" type="datetimeFigureOut">
              <a:rPr lang="en-JP" smtClean="0"/>
              <a:t>2023/06/20</a:t>
            </a:fld>
            <a:endParaRPr lang="en-JP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5535C4F-8BE8-A5C0-2400-8D7EDEA710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74BAE7B-4D30-27EE-0E08-3C29E25462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66D73-07E6-AA45-862D-7F8EF713986E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134182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FF7B97-7576-DAE3-DD17-FEE325B5C0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JP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A50B15D-0296-6887-0DF3-175B2DCABC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2E738-34EC-3F48-B735-D9EF3143412C}" type="datetimeFigureOut">
              <a:rPr lang="en-JP" smtClean="0"/>
              <a:t>2023/06/20</a:t>
            </a:fld>
            <a:endParaRPr lang="en-JP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0A879E4-D6C0-46EB-3C07-43617B75A1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F774BC7-9DA8-EF69-B74A-DB25DBFDAE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66D73-07E6-AA45-862D-7F8EF713986E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8334133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E904D9B-19AA-AD05-E0FB-86BE438A74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2E738-34EC-3F48-B735-D9EF3143412C}" type="datetimeFigureOut">
              <a:rPr lang="en-JP" smtClean="0"/>
              <a:t>2023/06/20</a:t>
            </a:fld>
            <a:endParaRPr lang="en-JP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805FC30-B13E-F54B-C3C1-C943999A00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31323D8-677E-D465-23F4-FB943388E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66D73-07E6-AA45-862D-7F8EF713986E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6101461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3F35BB-E5B7-FB26-EA6E-8EEF7C8904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7671FA-E8E7-301E-8FF0-9FC902C5FC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JP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91111C3-B632-7C37-D2A2-4147BA5D36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9C67AE-8B84-6D43-0FD9-61A7ED2170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2E738-34EC-3F48-B735-D9EF3143412C}" type="datetimeFigureOut">
              <a:rPr lang="en-JP" smtClean="0"/>
              <a:t>2023/06/20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CC55F4-30BE-3B81-817D-A6D949D721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B1FF53-E952-3F25-772A-F946DD3EC7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66D73-07E6-AA45-862D-7F8EF713986E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3104896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99B8B5-C294-BE08-B95F-14AD9AD7B5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JP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FBE0880-6A03-AC7D-52EA-1D0C7A4D4E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JP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236CC3-2117-A50A-AA86-5DE9FD1F2D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325F8F-D0C7-F749-B7C7-0C5ECBC38E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42E738-34EC-3F48-B735-D9EF3143412C}" type="datetimeFigureOut">
              <a:rPr lang="en-JP" smtClean="0"/>
              <a:t>2023/06/20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12E54F-60CD-82EC-7064-FA5A470F1C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EC97E8-3811-1A14-B6B4-7191406BF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66D73-07E6-AA45-862D-7F8EF713986E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9015404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EDACF25-DAF4-BE77-05A9-7B4A8849F7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AD9F387-C2AE-FD05-11CB-D83BE13339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D19C17-7B00-231D-8EE0-088E0992F60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42E738-34EC-3F48-B735-D9EF3143412C}" type="datetimeFigureOut">
              <a:rPr lang="en-JP" smtClean="0"/>
              <a:t>2023/06/20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F6BA74-0D89-DDD4-0555-A02F5DB7ABC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071BFD-FDEC-17BF-2B6A-B60168A974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A66D73-07E6-AA45-862D-7F8EF713986E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097212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JP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E464A436-3048-A838-45FD-CA6D722D8648}"/>
              </a:ext>
            </a:extLst>
          </p:cNvPr>
          <p:cNvGrpSpPr/>
          <p:nvPr/>
        </p:nvGrpSpPr>
        <p:grpSpPr>
          <a:xfrm>
            <a:off x="499350" y="463813"/>
            <a:ext cx="7385458" cy="4886566"/>
            <a:chOff x="478413" y="229638"/>
            <a:chExt cx="7385458" cy="4886566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02A25C5B-F9BF-1CD2-D774-B189F5EE34B1}"/>
                </a:ext>
              </a:extLst>
            </p:cNvPr>
            <p:cNvGrpSpPr/>
            <p:nvPr/>
          </p:nvGrpSpPr>
          <p:grpSpPr>
            <a:xfrm>
              <a:off x="645125" y="1019270"/>
              <a:ext cx="5022351" cy="4096934"/>
              <a:chOff x="1202090" y="1203936"/>
              <a:chExt cx="4134080" cy="3488773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73A90B5C-9870-D611-014F-5993F4157FC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505360" y="1203936"/>
                <a:ext cx="3830810" cy="3488773"/>
              </a:xfrm>
              <a:prstGeom prst="rect">
                <a:avLst/>
              </a:prstGeom>
            </p:spPr>
          </p:pic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021055FD-ED84-12F8-BE9B-76E41D970FC8}"/>
                  </a:ext>
                </a:extLst>
              </p:cNvPr>
              <p:cNvSpPr txBox="1"/>
              <p:nvPr/>
            </p:nvSpPr>
            <p:spPr>
              <a:xfrm rot="16200000">
                <a:off x="921099" y="2371388"/>
                <a:ext cx="992663" cy="4306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 viability</a:t>
                </a:r>
              </a:p>
              <a:p>
                <a:r>
                  <a:rPr lang="en-JP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 of control</a:t>
                </a:r>
              </a:p>
            </p:txBody>
          </p:sp>
        </p:grp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B0BDCA9-4A14-71DA-ABF0-093174C000E7}"/>
                </a:ext>
              </a:extLst>
            </p:cNvPr>
            <p:cNvSpPr txBox="1"/>
            <p:nvPr/>
          </p:nvSpPr>
          <p:spPr>
            <a:xfrm>
              <a:off x="478413" y="229638"/>
              <a:ext cx="8643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S1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6680800-D698-C00C-5482-7B8A1BE1CA69}"/>
                </a:ext>
              </a:extLst>
            </p:cNvPr>
            <p:cNvSpPr txBox="1"/>
            <p:nvPr/>
          </p:nvSpPr>
          <p:spPr>
            <a:xfrm>
              <a:off x="6999532" y="414304"/>
              <a:ext cx="8643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S2</a:t>
              </a:r>
              <a:endParaRPr lang="en-JP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7" name="図 1">
            <a:extLst>
              <a:ext uri="{FF2B5EF4-FFF2-40B4-BE49-F238E27FC236}">
                <a16:creationId xmlns:a16="http://schemas.microsoft.com/office/drawing/2014/main" id="{A97F06F8-E36D-44F8-A44E-DD58F9435B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79800" y="1253445"/>
            <a:ext cx="5974307" cy="49011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93043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EAAEB60-B155-F1CD-DCEE-2266AF57A10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98629" y="84519"/>
            <a:ext cx="10292331" cy="654814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2F862B1-60AD-C10B-D226-BDC920CB851E}"/>
              </a:ext>
            </a:extLst>
          </p:cNvPr>
          <p:cNvSpPr txBox="1"/>
          <p:nvPr/>
        </p:nvSpPr>
        <p:spPr>
          <a:xfrm>
            <a:off x="9966960" y="2590800"/>
            <a:ext cx="1524000" cy="6248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JP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C3E3344-B4D2-ECA1-AD00-13FFCB7B5E44}"/>
              </a:ext>
            </a:extLst>
          </p:cNvPr>
          <p:cNvSpPr txBox="1"/>
          <p:nvPr/>
        </p:nvSpPr>
        <p:spPr>
          <a:xfrm>
            <a:off x="0" y="0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</a:t>
            </a:r>
          </a:p>
        </p:txBody>
      </p:sp>
    </p:spTree>
    <p:extLst>
      <p:ext uri="{BB962C8B-B14F-4D97-AF65-F5344CB8AC3E}">
        <p14:creationId xmlns:p14="http://schemas.microsoft.com/office/powerpoint/2010/main" val="18630184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Group 39">
            <a:extLst>
              <a:ext uri="{FF2B5EF4-FFF2-40B4-BE49-F238E27FC236}">
                <a16:creationId xmlns:a16="http://schemas.microsoft.com/office/drawing/2014/main" id="{F7EFBDA5-F1FF-7ABC-FD56-F58EFAA9B8A8}"/>
              </a:ext>
            </a:extLst>
          </p:cNvPr>
          <p:cNvGrpSpPr/>
          <p:nvPr/>
        </p:nvGrpSpPr>
        <p:grpSpPr>
          <a:xfrm>
            <a:off x="1269166" y="218660"/>
            <a:ext cx="4455773" cy="2854388"/>
            <a:chOff x="1933550" y="73974"/>
            <a:chExt cx="4804106" cy="3247418"/>
          </a:xfrm>
        </p:grpSpPr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4636AE02-14D2-CA38-A28B-9ED29DB27E24}"/>
                </a:ext>
              </a:extLst>
            </p:cNvPr>
            <p:cNvGrpSpPr/>
            <p:nvPr/>
          </p:nvGrpSpPr>
          <p:grpSpPr>
            <a:xfrm>
              <a:off x="2317845" y="356649"/>
              <a:ext cx="108708" cy="2673017"/>
              <a:chOff x="2302102" y="323849"/>
              <a:chExt cx="108708" cy="2673017"/>
            </a:xfrm>
          </p:grpSpPr>
          <p:sp>
            <p:nvSpPr>
              <p:cNvPr id="11" name="Left Bracket 10">
                <a:extLst>
                  <a:ext uri="{FF2B5EF4-FFF2-40B4-BE49-F238E27FC236}">
                    <a16:creationId xmlns:a16="http://schemas.microsoft.com/office/drawing/2014/main" id="{60829975-F757-8B69-203C-62D7BB36A5CB}"/>
                  </a:ext>
                </a:extLst>
              </p:cNvPr>
              <p:cNvSpPr/>
              <p:nvPr/>
            </p:nvSpPr>
            <p:spPr>
              <a:xfrm>
                <a:off x="2310384" y="323849"/>
                <a:ext cx="86967" cy="824491"/>
              </a:xfrm>
              <a:prstGeom prst="leftBracket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JP"/>
              </a:p>
            </p:txBody>
          </p:sp>
          <p:sp>
            <p:nvSpPr>
              <p:cNvPr id="12" name="Left Bracket 11">
                <a:extLst>
                  <a:ext uri="{FF2B5EF4-FFF2-40B4-BE49-F238E27FC236}">
                    <a16:creationId xmlns:a16="http://schemas.microsoft.com/office/drawing/2014/main" id="{EC8CBE98-FB24-63B3-B52B-81A3F9D7D288}"/>
                  </a:ext>
                </a:extLst>
              </p:cNvPr>
              <p:cNvSpPr/>
              <p:nvPr/>
            </p:nvSpPr>
            <p:spPr>
              <a:xfrm>
                <a:off x="2302102" y="1991359"/>
                <a:ext cx="106680" cy="1005507"/>
              </a:xfrm>
              <a:prstGeom prst="leftBracket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JP"/>
              </a:p>
            </p:txBody>
          </p:sp>
          <p:sp>
            <p:nvSpPr>
              <p:cNvPr id="16" name="Left Bracket 15">
                <a:extLst>
                  <a:ext uri="{FF2B5EF4-FFF2-40B4-BE49-F238E27FC236}">
                    <a16:creationId xmlns:a16="http://schemas.microsoft.com/office/drawing/2014/main" id="{0C8A9F57-66AF-618B-4A2A-17418A0940BF}"/>
                  </a:ext>
                </a:extLst>
              </p:cNvPr>
              <p:cNvSpPr/>
              <p:nvPr/>
            </p:nvSpPr>
            <p:spPr>
              <a:xfrm>
                <a:off x="2302102" y="1411351"/>
                <a:ext cx="108708" cy="393197"/>
              </a:xfrm>
              <a:prstGeom prst="leftBracket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JP"/>
              </a:p>
            </p:txBody>
          </p:sp>
        </p:grp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AD0E7F2-A52D-9D34-4DB8-CAB76313CD3B}"/>
                </a:ext>
              </a:extLst>
            </p:cNvPr>
            <p:cNvSpPr txBox="1"/>
            <p:nvPr/>
          </p:nvSpPr>
          <p:spPr>
            <a:xfrm rot="16200000">
              <a:off x="1398823" y="624228"/>
              <a:ext cx="150061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 signalling </a:t>
              </a:r>
            </a:p>
            <a:p>
              <a:pPr algn="ctr"/>
              <a:r>
                <a:rPr lang="en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thways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A8758FC-969D-B5E4-0FA3-35D26C489BED}"/>
                </a:ext>
              </a:extLst>
            </p:cNvPr>
            <p:cNvSpPr txBox="1"/>
            <p:nvPr/>
          </p:nvSpPr>
          <p:spPr>
            <a:xfrm rot="16200000">
              <a:off x="1630109" y="2368328"/>
              <a:ext cx="11420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flammation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717A728C-9709-3F8F-D8F1-FC95175E952C}"/>
                </a:ext>
              </a:extLst>
            </p:cNvPr>
            <p:cNvSpPr txBox="1"/>
            <p:nvPr/>
          </p:nvSpPr>
          <p:spPr>
            <a:xfrm rot="16200000">
              <a:off x="1610606" y="1458363"/>
              <a:ext cx="104599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nergy metabolism</a:t>
              </a:r>
            </a:p>
          </p:txBody>
        </p:sp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99AD68D3-95F9-973D-7F9E-41E9A2725F3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15462" y="179486"/>
              <a:ext cx="4222194" cy="3141906"/>
            </a:xfrm>
            <a:prstGeom prst="rect">
              <a:avLst/>
            </a:prstGeom>
          </p:spPr>
        </p:pic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40F0D195-EF27-BCBA-9027-1E87C12F9DDF}"/>
              </a:ext>
            </a:extLst>
          </p:cNvPr>
          <p:cNvGrpSpPr/>
          <p:nvPr/>
        </p:nvGrpSpPr>
        <p:grpSpPr>
          <a:xfrm>
            <a:off x="1298451" y="3098297"/>
            <a:ext cx="4389488" cy="3013249"/>
            <a:chOff x="1867858" y="3154849"/>
            <a:chExt cx="4732639" cy="3428154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6E5554EF-E027-0ECE-C704-4568E786C3B5}"/>
                </a:ext>
              </a:extLst>
            </p:cNvPr>
            <p:cNvSpPr txBox="1"/>
            <p:nvPr/>
          </p:nvSpPr>
          <p:spPr>
            <a:xfrm rot="16200000">
              <a:off x="1381995" y="3705103"/>
              <a:ext cx="150061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 signalling </a:t>
              </a:r>
            </a:p>
            <a:p>
              <a:pPr algn="ctr"/>
              <a:r>
                <a:rPr lang="en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thways</a:t>
              </a:r>
            </a:p>
          </p:txBody>
        </p:sp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F17282D7-31AA-5621-92AA-DD20A3F90E68}"/>
                </a:ext>
              </a:extLst>
            </p:cNvPr>
            <p:cNvGrpSpPr/>
            <p:nvPr/>
          </p:nvGrpSpPr>
          <p:grpSpPr>
            <a:xfrm>
              <a:off x="1867858" y="3441096"/>
              <a:ext cx="4732639" cy="3141907"/>
              <a:chOff x="1867858" y="3288696"/>
              <a:chExt cx="4732639" cy="3141907"/>
            </a:xfrm>
          </p:grpSpPr>
          <p:grpSp>
            <p:nvGrpSpPr>
              <p:cNvPr id="37" name="Group 36">
                <a:extLst>
                  <a:ext uri="{FF2B5EF4-FFF2-40B4-BE49-F238E27FC236}">
                    <a16:creationId xmlns:a16="http://schemas.microsoft.com/office/drawing/2014/main" id="{66FF3040-F87D-2742-194D-BCF8121B155E}"/>
                  </a:ext>
                </a:extLst>
              </p:cNvPr>
              <p:cNvGrpSpPr/>
              <p:nvPr/>
            </p:nvGrpSpPr>
            <p:grpSpPr>
              <a:xfrm>
                <a:off x="1867858" y="3332802"/>
                <a:ext cx="542952" cy="2997059"/>
                <a:chOff x="1867858" y="3332802"/>
                <a:chExt cx="542952" cy="2997059"/>
              </a:xfrm>
            </p:grpSpPr>
            <p:grpSp>
              <p:nvGrpSpPr>
                <p:cNvPr id="20" name="Group 19">
                  <a:extLst>
                    <a:ext uri="{FF2B5EF4-FFF2-40B4-BE49-F238E27FC236}">
                      <a16:creationId xmlns:a16="http://schemas.microsoft.com/office/drawing/2014/main" id="{3BBCA7E7-C1AF-B01F-1695-9E72B1244B4A}"/>
                    </a:ext>
                  </a:extLst>
                </p:cNvPr>
                <p:cNvGrpSpPr/>
                <p:nvPr/>
              </p:nvGrpSpPr>
              <p:grpSpPr>
                <a:xfrm>
                  <a:off x="2302102" y="3332802"/>
                  <a:ext cx="108708" cy="2699906"/>
                  <a:chOff x="2286300" y="3084944"/>
                  <a:chExt cx="108708" cy="2699906"/>
                </a:xfrm>
              </p:grpSpPr>
              <p:sp>
                <p:nvSpPr>
                  <p:cNvPr id="13" name="Left Bracket 12">
                    <a:extLst>
                      <a:ext uri="{FF2B5EF4-FFF2-40B4-BE49-F238E27FC236}">
                        <a16:creationId xmlns:a16="http://schemas.microsoft.com/office/drawing/2014/main" id="{16F76C59-A4E3-01F4-0AED-C1A7AA4BCDFF}"/>
                      </a:ext>
                    </a:extLst>
                  </p:cNvPr>
                  <p:cNvSpPr/>
                  <p:nvPr/>
                </p:nvSpPr>
                <p:spPr>
                  <a:xfrm>
                    <a:off x="2308041" y="3084944"/>
                    <a:ext cx="86967" cy="824491"/>
                  </a:xfrm>
                  <a:prstGeom prst="leftBracket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JP"/>
                  </a:p>
                </p:txBody>
              </p:sp>
              <p:sp>
                <p:nvSpPr>
                  <p:cNvPr id="14" name="Left Bracket 13">
                    <a:extLst>
                      <a:ext uri="{FF2B5EF4-FFF2-40B4-BE49-F238E27FC236}">
                        <a16:creationId xmlns:a16="http://schemas.microsoft.com/office/drawing/2014/main" id="{D77F2E22-2267-C5DC-34AB-058848E0193D}"/>
                      </a:ext>
                    </a:extLst>
                  </p:cNvPr>
                  <p:cNvSpPr/>
                  <p:nvPr/>
                </p:nvSpPr>
                <p:spPr>
                  <a:xfrm>
                    <a:off x="2286300" y="4146549"/>
                    <a:ext cx="106457" cy="1045997"/>
                  </a:xfrm>
                  <a:prstGeom prst="leftBracket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JP"/>
                  </a:p>
                </p:txBody>
              </p:sp>
              <p:sp>
                <p:nvSpPr>
                  <p:cNvPr id="15" name="Left Bracket 14">
                    <a:extLst>
                      <a:ext uri="{FF2B5EF4-FFF2-40B4-BE49-F238E27FC236}">
                        <a16:creationId xmlns:a16="http://schemas.microsoft.com/office/drawing/2014/main" id="{8B1F0693-3657-FB4C-DF2B-9BF80B4A2D0A}"/>
                      </a:ext>
                    </a:extLst>
                  </p:cNvPr>
                  <p:cNvSpPr/>
                  <p:nvPr/>
                </p:nvSpPr>
                <p:spPr>
                  <a:xfrm>
                    <a:off x="2286300" y="5391653"/>
                    <a:ext cx="108708" cy="393197"/>
                  </a:xfrm>
                  <a:prstGeom prst="leftBracket">
                    <a:avLst/>
                  </a:prstGeom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JP"/>
                  </a:p>
                </p:txBody>
              </p:sp>
            </p:grpSp>
            <p:sp>
              <p:nvSpPr>
                <p:cNvPr id="25" name="TextBox 24">
                  <a:extLst>
                    <a:ext uri="{FF2B5EF4-FFF2-40B4-BE49-F238E27FC236}">
                      <a16:creationId xmlns:a16="http://schemas.microsoft.com/office/drawing/2014/main" id="{5E202CA9-85C0-37B0-7D0C-BB275C0F7EA1}"/>
                    </a:ext>
                  </a:extLst>
                </p:cNvPr>
                <p:cNvSpPr txBox="1"/>
                <p:nvPr/>
              </p:nvSpPr>
              <p:spPr>
                <a:xfrm rot="16200000">
                  <a:off x="1663613" y="4794295"/>
                  <a:ext cx="104599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JP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nflammation</a:t>
                  </a:r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FEEBF8E6-E810-B757-1471-91CDDA39CD5A}"/>
                    </a:ext>
                  </a:extLst>
                </p:cNvPr>
                <p:cNvSpPr txBox="1"/>
                <p:nvPr/>
              </p:nvSpPr>
              <p:spPr>
                <a:xfrm rot="16200000">
                  <a:off x="1544914" y="5606808"/>
                  <a:ext cx="1045997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JP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nergy metabolism</a:t>
                  </a:r>
                </a:p>
              </p:txBody>
            </p:sp>
          </p:grpSp>
          <p:pic>
            <p:nvPicPr>
              <p:cNvPr id="36" name="Picture 35">
                <a:extLst>
                  <a:ext uri="{FF2B5EF4-FFF2-40B4-BE49-F238E27FC236}">
                    <a16:creationId xmlns:a16="http://schemas.microsoft.com/office/drawing/2014/main" id="{0509ABA6-22FC-8E2E-0DEF-29306341D92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378302" y="3288696"/>
                <a:ext cx="4222195" cy="3141907"/>
              </a:xfrm>
              <a:prstGeom prst="rect">
                <a:avLst/>
              </a:prstGeom>
            </p:spPr>
          </p:pic>
        </p:grpSp>
      </p:grpSp>
      <p:sp>
        <p:nvSpPr>
          <p:cNvPr id="41" name="テキスト ボックス 5">
            <a:extLst>
              <a:ext uri="{FF2B5EF4-FFF2-40B4-BE49-F238E27FC236}">
                <a16:creationId xmlns:a16="http://schemas.microsoft.com/office/drawing/2014/main" id="{09590FDB-F5D4-80D1-6A96-F60CACBB812B}"/>
              </a:ext>
            </a:extLst>
          </p:cNvPr>
          <p:cNvSpPr txBox="1"/>
          <p:nvPr/>
        </p:nvSpPr>
        <p:spPr>
          <a:xfrm rot="16200000">
            <a:off x="235569" y="4481812"/>
            <a:ext cx="15327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AMP8 TG 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AMP8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11">
            <a:extLst>
              <a:ext uri="{FF2B5EF4-FFF2-40B4-BE49-F238E27FC236}">
                <a16:creationId xmlns:a16="http://schemas.microsoft.com/office/drawing/2014/main" id="{EB028BBC-C925-8681-6CC9-5E084FC62CEF}"/>
              </a:ext>
            </a:extLst>
          </p:cNvPr>
          <p:cNvSpPr txBox="1"/>
          <p:nvPr/>
        </p:nvSpPr>
        <p:spPr>
          <a:xfrm rot="16200000">
            <a:off x="418614" y="1530027"/>
            <a:ext cx="1327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AMP8 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AMR1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Left Bracket 42">
            <a:extLst>
              <a:ext uri="{FF2B5EF4-FFF2-40B4-BE49-F238E27FC236}">
                <a16:creationId xmlns:a16="http://schemas.microsoft.com/office/drawing/2014/main" id="{ECC05AF5-2F99-FF34-E4D0-B54894F6D36D}"/>
              </a:ext>
            </a:extLst>
          </p:cNvPr>
          <p:cNvSpPr/>
          <p:nvPr/>
        </p:nvSpPr>
        <p:spPr>
          <a:xfrm>
            <a:off x="1156476" y="516545"/>
            <a:ext cx="112014" cy="2189592"/>
          </a:xfrm>
          <a:prstGeom prst="leftBracket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Left Bracket 46">
            <a:extLst>
              <a:ext uri="{FF2B5EF4-FFF2-40B4-BE49-F238E27FC236}">
                <a16:creationId xmlns:a16="http://schemas.microsoft.com/office/drawing/2014/main" id="{4A2A6826-5DA6-D15C-1556-CA5D2FD54A17}"/>
              </a:ext>
            </a:extLst>
          </p:cNvPr>
          <p:cNvSpPr/>
          <p:nvPr/>
        </p:nvSpPr>
        <p:spPr>
          <a:xfrm>
            <a:off x="1186437" y="3510371"/>
            <a:ext cx="112014" cy="2189592"/>
          </a:xfrm>
          <a:prstGeom prst="leftBracket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89EF191-AC8C-B33B-8056-F3E90A91F094}"/>
              </a:ext>
            </a:extLst>
          </p:cNvPr>
          <p:cNvSpPr txBox="1"/>
          <p:nvPr/>
        </p:nvSpPr>
        <p:spPr>
          <a:xfrm>
            <a:off x="604042" y="0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B9B79FD-9A06-6EED-8FD4-165EC4102EF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05955" y="678762"/>
            <a:ext cx="5798330" cy="526592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44C446F-28C8-4A1C-96E7-C35D5CF640A7}"/>
              </a:ext>
            </a:extLst>
          </p:cNvPr>
          <p:cNvSpPr txBox="1"/>
          <p:nvPr/>
        </p:nvSpPr>
        <p:spPr>
          <a:xfrm>
            <a:off x="6231122" y="73694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</a:t>
            </a:r>
          </a:p>
        </p:txBody>
      </p:sp>
    </p:spTree>
    <p:extLst>
      <p:ext uri="{BB962C8B-B14F-4D97-AF65-F5344CB8AC3E}">
        <p14:creationId xmlns:p14="http://schemas.microsoft.com/office/powerpoint/2010/main" val="27257923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1</TotalTime>
  <Words>40</Words>
  <Application>Microsoft Macintosh PowerPoint</Application>
  <PresentationFormat>Widescreen</PresentationFormat>
  <Paragraphs>18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kter Sharmin</dc:creator>
  <cp:lastModifiedBy>sharmin aktar</cp:lastModifiedBy>
  <cp:revision>3</cp:revision>
  <dcterms:created xsi:type="dcterms:W3CDTF">2023-01-30T01:13:29Z</dcterms:created>
  <dcterms:modified xsi:type="dcterms:W3CDTF">2023-06-20T08:40:40Z</dcterms:modified>
</cp:coreProperties>
</file>